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93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100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D478DE-0668-429A-8161-43BCAF93E78E}" type="datetimeFigureOut">
              <a:rPr lang="en-SE" smtClean="0"/>
              <a:t>2025-07-10</a:t>
            </a:fld>
            <a:endParaRPr lang="en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6ABC9-6ABC-4D27-9A19-34CA49C6FD6E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7644394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D478DE-0668-429A-8161-43BCAF93E78E}" type="datetimeFigureOut">
              <a:rPr lang="en-SE" smtClean="0"/>
              <a:t>2025-07-10</a:t>
            </a:fld>
            <a:endParaRPr lang="en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6ABC9-6ABC-4D27-9A19-34CA49C6FD6E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8374225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D478DE-0668-429A-8161-43BCAF93E78E}" type="datetimeFigureOut">
              <a:rPr lang="en-SE" smtClean="0"/>
              <a:t>2025-07-10</a:t>
            </a:fld>
            <a:endParaRPr lang="en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6ABC9-6ABC-4D27-9A19-34CA49C6FD6E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9770510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D478DE-0668-429A-8161-43BCAF93E78E}" type="datetimeFigureOut">
              <a:rPr lang="en-SE" smtClean="0"/>
              <a:t>2025-07-10</a:t>
            </a:fld>
            <a:endParaRPr lang="en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6ABC9-6ABC-4D27-9A19-34CA49C6FD6E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4459539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D478DE-0668-429A-8161-43BCAF93E78E}" type="datetimeFigureOut">
              <a:rPr lang="en-SE" smtClean="0"/>
              <a:t>2025-07-10</a:t>
            </a:fld>
            <a:endParaRPr lang="en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6ABC9-6ABC-4D27-9A19-34CA49C6FD6E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9129767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D478DE-0668-429A-8161-43BCAF93E78E}" type="datetimeFigureOut">
              <a:rPr lang="en-SE" smtClean="0"/>
              <a:t>2025-07-10</a:t>
            </a:fld>
            <a:endParaRPr lang="en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6ABC9-6ABC-4D27-9A19-34CA49C6FD6E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41952102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D478DE-0668-429A-8161-43BCAF93E78E}" type="datetimeFigureOut">
              <a:rPr lang="en-SE" smtClean="0"/>
              <a:t>2025-07-10</a:t>
            </a:fld>
            <a:endParaRPr lang="en-S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6ABC9-6ABC-4D27-9A19-34CA49C6FD6E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3812913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D478DE-0668-429A-8161-43BCAF93E78E}" type="datetimeFigureOut">
              <a:rPr lang="en-SE" smtClean="0"/>
              <a:t>2025-07-10</a:t>
            </a:fld>
            <a:endParaRPr lang="en-S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6ABC9-6ABC-4D27-9A19-34CA49C6FD6E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530308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D478DE-0668-429A-8161-43BCAF93E78E}" type="datetimeFigureOut">
              <a:rPr lang="en-SE" smtClean="0"/>
              <a:t>2025-07-10</a:t>
            </a:fld>
            <a:endParaRPr lang="en-S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6ABC9-6ABC-4D27-9A19-34CA49C6FD6E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1733534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D478DE-0668-429A-8161-43BCAF93E78E}" type="datetimeFigureOut">
              <a:rPr lang="en-SE" smtClean="0"/>
              <a:t>2025-07-10</a:t>
            </a:fld>
            <a:endParaRPr lang="en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6ABC9-6ABC-4D27-9A19-34CA49C6FD6E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5768605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D478DE-0668-429A-8161-43BCAF93E78E}" type="datetimeFigureOut">
              <a:rPr lang="en-SE" smtClean="0"/>
              <a:t>2025-07-10</a:t>
            </a:fld>
            <a:endParaRPr lang="en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6ABC9-6ABC-4D27-9A19-34CA49C6FD6E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4666867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D478DE-0668-429A-8161-43BCAF93E78E}" type="datetimeFigureOut">
              <a:rPr lang="en-SE" smtClean="0"/>
              <a:t>2025-07-10</a:t>
            </a:fld>
            <a:endParaRPr lang="en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F6ABC9-6ABC-4D27-9A19-34CA49C6FD6E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8166105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1B2915E9-E4A0-8B60-1849-F59BB4D7DA8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64332244"/>
              </p:ext>
            </p:extLst>
          </p:nvPr>
        </p:nvGraphicFramePr>
        <p:xfrm>
          <a:off x="105156" y="361027"/>
          <a:ext cx="8933688" cy="593870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977896">
                  <a:extLst>
                    <a:ext uri="{9D8B030D-6E8A-4147-A177-3AD203B41FA5}">
                      <a16:colId xmlns:a16="http://schemas.microsoft.com/office/drawing/2014/main" val="898427682"/>
                    </a:ext>
                  </a:extLst>
                </a:gridCol>
                <a:gridCol w="2977896">
                  <a:extLst>
                    <a:ext uri="{9D8B030D-6E8A-4147-A177-3AD203B41FA5}">
                      <a16:colId xmlns:a16="http://schemas.microsoft.com/office/drawing/2014/main" val="1942726772"/>
                    </a:ext>
                  </a:extLst>
                </a:gridCol>
                <a:gridCol w="2977896">
                  <a:extLst>
                    <a:ext uri="{9D8B030D-6E8A-4147-A177-3AD203B41FA5}">
                      <a16:colId xmlns:a16="http://schemas.microsoft.com/office/drawing/2014/main" val="792497477"/>
                    </a:ext>
                  </a:extLst>
                </a:gridCol>
              </a:tblGrid>
              <a:tr h="320607">
                <a:tc>
                  <a:txBody>
                    <a:bodyPr/>
                    <a:lstStyle/>
                    <a:p>
                      <a:r>
                        <a:rPr lang="en-US" sz="1000" dirty="0">
                          <a:solidFill>
                            <a:schemeClr val="tx1"/>
                          </a:solidFill>
                        </a:rPr>
                        <a:t>Primary Outcome Measure</a:t>
                      </a:r>
                      <a:endParaRPr lang="en-SE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>
                          <a:solidFill>
                            <a:schemeClr val="tx1"/>
                          </a:solidFill>
                        </a:rPr>
                        <a:t>Measure Description</a:t>
                      </a:r>
                      <a:endParaRPr lang="en-SE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>
                          <a:solidFill>
                            <a:schemeClr val="tx1"/>
                          </a:solidFill>
                        </a:rPr>
                        <a:t>Time Frame</a:t>
                      </a:r>
                      <a:endParaRPr lang="en-SE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46122417"/>
                  </a:ext>
                </a:extLst>
              </a:tr>
              <a:tr h="478093">
                <a:tc>
                  <a:txBody>
                    <a:bodyPr/>
                    <a:lstStyle/>
                    <a:p>
                      <a:r>
                        <a:rPr lang="en-US" sz="1000" dirty="0"/>
                        <a:t>Acute postoperative pain intensity</a:t>
                      </a:r>
                      <a:endParaRPr lang="en-SE" sz="1000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Average pain intensity (NRS 0 – 10) over the past 24 h rated each morning, averaged over 7 days</a:t>
                      </a:r>
                      <a:endParaRPr lang="en-SE" sz="1000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/>
                        <a:t>First 7 postoperative days</a:t>
                      </a:r>
                      <a:endParaRPr lang="en-SE" sz="1000" dirty="0"/>
                    </a:p>
                    <a:p>
                      <a:endParaRPr lang="en-SE" sz="1000" dirty="0"/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02135391"/>
                  </a:ext>
                </a:extLst>
              </a:tr>
              <a:tr h="304717">
                <a:tc>
                  <a:txBody>
                    <a:bodyPr/>
                    <a:lstStyle/>
                    <a:p>
                      <a:r>
                        <a:rPr lang="en-US" sz="1000" b="1" dirty="0"/>
                        <a:t>Secondary Outcome Measure</a:t>
                      </a:r>
                    </a:p>
                  </a:txBody>
                  <a:tcPr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0" dirty="0"/>
                    </a:p>
                  </a:txBody>
                  <a:tcPr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0" dirty="0"/>
                    </a:p>
                  </a:txBody>
                  <a:tcPr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35197757"/>
                  </a:ext>
                </a:extLst>
              </a:tr>
              <a:tr h="415334">
                <a:tc>
                  <a:txBody>
                    <a:bodyPr/>
                    <a:lstStyle/>
                    <a:p>
                      <a:r>
                        <a:rPr lang="en-US" sz="1000" dirty="0"/>
                        <a:t>Pre- and acute postoperative change in sleep measures from baseline</a:t>
                      </a:r>
                      <a:endParaRPr lang="en-SE" sz="1000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Insomnia severity index (ISI) score, </a:t>
                      </a:r>
                      <a:r>
                        <a:rPr lang="en-US" sz="1000" dirty="0" err="1"/>
                        <a:t>actigraphic</a:t>
                      </a:r>
                      <a:r>
                        <a:rPr lang="en-US" sz="1000" dirty="0"/>
                        <a:t> sleep continuity measures (sleep onset latency, total sleep time, wakefulness after sleep onset, sleep efficiency)</a:t>
                      </a:r>
                      <a:endParaRPr lang="en-SE" sz="1000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Up to 2 weeks postoperative</a:t>
                      </a:r>
                      <a:endParaRPr lang="en-SE" sz="1000" dirty="0"/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43365033"/>
                  </a:ext>
                </a:extLst>
              </a:tr>
              <a:tr h="415334">
                <a:tc>
                  <a:txBody>
                    <a:bodyPr/>
                    <a:lstStyle/>
                    <a:p>
                      <a:r>
                        <a:rPr lang="en-US" sz="1000" dirty="0"/>
                        <a:t>Acute postoperative opioid consumption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Oral morphine mg equivalents (OMEQs)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Postoperative day (POD) 1 and POD1-7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05571748"/>
                  </a:ext>
                </a:extLst>
              </a:tr>
              <a:tr h="415334">
                <a:tc>
                  <a:txBody>
                    <a:bodyPr/>
                    <a:lstStyle/>
                    <a:p>
                      <a:r>
                        <a:rPr lang="en-US" sz="1000" dirty="0"/>
                        <a:t>Recovery in the acute postoperative phase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Quality of recovery (</a:t>
                      </a:r>
                      <a:r>
                        <a:rPr lang="en-US" sz="1000" dirty="0" err="1"/>
                        <a:t>QoR</a:t>
                      </a:r>
                      <a:r>
                        <a:rPr lang="en-US" sz="1000" dirty="0"/>
                        <a:t>) 15 score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POD1-3, POD7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06149668"/>
                  </a:ext>
                </a:extLst>
              </a:tr>
              <a:tr h="415334">
                <a:tc>
                  <a:txBody>
                    <a:bodyPr/>
                    <a:lstStyle/>
                    <a:p>
                      <a:r>
                        <a:rPr lang="en-US" sz="1000" dirty="0"/>
                        <a:t>Long-term postoperative sleep quality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insomnia severity index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Up to 12 months postoperative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87287729"/>
                  </a:ext>
                </a:extLst>
              </a:tr>
              <a:tr h="415334">
                <a:tc>
                  <a:txBody>
                    <a:bodyPr/>
                    <a:lstStyle/>
                    <a:p>
                      <a:r>
                        <a:rPr lang="en-US" sz="1000" dirty="0"/>
                        <a:t>Postoperative objective sleep continuity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 err="1"/>
                        <a:t>Actigraphic</a:t>
                      </a:r>
                      <a:r>
                        <a:rPr lang="en-US" sz="1000" dirty="0"/>
                        <a:t> sleep efficiency [SE]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/>
                        <a:t>Up to 6 months postoperative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80439256"/>
                  </a:ext>
                </a:extLst>
              </a:tr>
              <a:tr h="415334">
                <a:tc>
                  <a:txBody>
                    <a:bodyPr/>
                    <a:lstStyle/>
                    <a:p>
                      <a:r>
                        <a:rPr lang="en-US" sz="1000" dirty="0"/>
                        <a:t>Pain intensity 6 months postoperative</a:t>
                      </a:r>
                      <a:endParaRPr lang="en-SE" sz="1000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Average pain intensity (NRS 0 – 10) over the past 24 h rated each morning, averaged over 7 days</a:t>
                      </a:r>
                      <a:endParaRPr lang="en-SE" sz="1000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6 months postoperative</a:t>
                      </a:r>
                      <a:endParaRPr lang="en-SE" sz="1000" dirty="0"/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96888387"/>
                  </a:ext>
                </a:extLst>
              </a:tr>
              <a:tr h="415334">
                <a:tc>
                  <a:txBody>
                    <a:bodyPr/>
                    <a:lstStyle/>
                    <a:p>
                      <a:r>
                        <a:rPr lang="en-US" sz="1000" dirty="0"/>
                        <a:t>Change in pain measures from baseline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BPI pain severity and pain interference score, QoR-15 pain score, WOMAC OA pain score 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Up to 12 months postoperative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23077073"/>
                  </a:ext>
                </a:extLst>
              </a:tr>
              <a:tr h="415334">
                <a:tc>
                  <a:txBody>
                    <a:bodyPr/>
                    <a:lstStyle/>
                    <a:p>
                      <a:r>
                        <a:rPr lang="en-US" sz="1000" dirty="0"/>
                        <a:t>Changes in quantitative sensory testing (QST) measures of pain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Pressure pain threshold, temporal summation, conditioned pain modulation, cold pressor test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Up to 6 months postoperative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90375157"/>
                  </a:ext>
                </a:extLst>
              </a:tr>
              <a:tr h="415334">
                <a:tc>
                  <a:txBody>
                    <a:bodyPr/>
                    <a:lstStyle/>
                    <a:p>
                      <a:r>
                        <a:rPr lang="en-US" sz="1000" dirty="0"/>
                        <a:t>Change in cognitive function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Digital cognitive testing (</a:t>
                      </a:r>
                      <a:r>
                        <a:rPr lang="en-US" sz="1000" dirty="0" err="1"/>
                        <a:t>Mindmore</a:t>
                      </a:r>
                      <a:r>
                        <a:rPr lang="en-US" sz="1000" dirty="0"/>
                        <a:t> platform) incl. memory, attention and processing speed, executive functions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Up to 6 months postoperative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51571958"/>
                  </a:ext>
                </a:extLst>
              </a:tr>
              <a:tr h="415334">
                <a:tc>
                  <a:txBody>
                    <a:bodyPr/>
                    <a:lstStyle/>
                    <a:p>
                      <a:r>
                        <a:rPr lang="en-US" sz="1000" dirty="0"/>
                        <a:t>Change in anxiety from baseline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Generalized anxiety disorder 7 (GAD-7) score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Up to 6 months postoperative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37730519"/>
                  </a:ext>
                </a:extLst>
              </a:tr>
              <a:tr h="415334">
                <a:tc>
                  <a:txBody>
                    <a:bodyPr/>
                    <a:lstStyle/>
                    <a:p>
                      <a:r>
                        <a:rPr lang="en-US" sz="1000"/>
                        <a:t>Change in depression from baseline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Patient health questionnaire 9 (PHQ-9</a:t>
                      </a:r>
                      <a:r>
                        <a:rPr lang="en-US" sz="1000"/>
                        <a:t>) score</a:t>
                      </a:r>
                      <a:endParaRPr lang="en-US" sz="1000" dirty="0"/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Up to 6 months postoperative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2277419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8177599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1B2915E9-E4A0-8B60-1849-F59BB4D7DA8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68326893"/>
              </p:ext>
            </p:extLst>
          </p:nvPr>
        </p:nvGraphicFramePr>
        <p:xfrm>
          <a:off x="100584" y="118872"/>
          <a:ext cx="8933688" cy="499427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977896">
                  <a:extLst>
                    <a:ext uri="{9D8B030D-6E8A-4147-A177-3AD203B41FA5}">
                      <a16:colId xmlns:a16="http://schemas.microsoft.com/office/drawing/2014/main" val="898427682"/>
                    </a:ext>
                  </a:extLst>
                </a:gridCol>
                <a:gridCol w="2977896">
                  <a:extLst>
                    <a:ext uri="{9D8B030D-6E8A-4147-A177-3AD203B41FA5}">
                      <a16:colId xmlns:a16="http://schemas.microsoft.com/office/drawing/2014/main" val="1942726772"/>
                    </a:ext>
                  </a:extLst>
                </a:gridCol>
                <a:gridCol w="2977896">
                  <a:extLst>
                    <a:ext uri="{9D8B030D-6E8A-4147-A177-3AD203B41FA5}">
                      <a16:colId xmlns:a16="http://schemas.microsoft.com/office/drawing/2014/main" val="792497477"/>
                    </a:ext>
                  </a:extLst>
                </a:gridCol>
              </a:tblGrid>
              <a:tr h="405668">
                <a:tc>
                  <a:txBody>
                    <a:bodyPr/>
                    <a:lstStyle/>
                    <a:p>
                      <a:r>
                        <a:rPr lang="en-US" sz="1000" dirty="0">
                          <a:solidFill>
                            <a:schemeClr val="tx1"/>
                          </a:solidFill>
                        </a:rPr>
                        <a:t>Secondary Outcome Measure (continued)</a:t>
                      </a:r>
                      <a:endParaRPr lang="en-SE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>
                          <a:solidFill>
                            <a:schemeClr val="tx1"/>
                          </a:solidFill>
                        </a:rPr>
                        <a:t>Measure Description</a:t>
                      </a:r>
                      <a:endParaRPr lang="en-SE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>
                          <a:solidFill>
                            <a:schemeClr val="tx1"/>
                          </a:solidFill>
                        </a:rPr>
                        <a:t>Time Frame</a:t>
                      </a:r>
                      <a:endParaRPr lang="en-SE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46122417"/>
                  </a:ext>
                </a:extLst>
              </a:tr>
              <a:tr h="425302">
                <a:tc>
                  <a:txBody>
                    <a:bodyPr/>
                    <a:lstStyle/>
                    <a:p>
                      <a:r>
                        <a:rPr lang="en-US" sz="1000" dirty="0"/>
                        <a:t>Change in quality of life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 err="1"/>
                        <a:t>EuroQol</a:t>
                      </a:r>
                      <a:r>
                        <a:rPr lang="en-US" sz="1000" dirty="0"/>
                        <a:t> 5 dimension 5 level (EQ-5D-5L), RAND-36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Up to 6 months postoperative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02135391"/>
                  </a:ext>
                </a:extLst>
              </a:tr>
              <a:tr h="425302">
                <a:tc>
                  <a:txBody>
                    <a:bodyPr/>
                    <a:lstStyle/>
                    <a:p>
                      <a:r>
                        <a:rPr lang="en-US" sz="1000" dirty="0"/>
                        <a:t>Change in health-related function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EQ-5D-5L, RAND-36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Up to 6 months postoperative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58564303"/>
                  </a:ext>
                </a:extLst>
              </a:tr>
              <a:tr h="415334">
                <a:tc>
                  <a:txBody>
                    <a:bodyPr/>
                    <a:lstStyle/>
                    <a:p>
                      <a:r>
                        <a:rPr lang="en-US" sz="1000" dirty="0"/>
                        <a:t>Change in osteoarthritis-related symptoms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Western Ontario and McMaster Universities Osteoarthritis Index (WOMAC OA)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Up to 12 months postoperative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71590040"/>
                  </a:ext>
                </a:extLst>
              </a:tr>
              <a:tr h="415334">
                <a:tc>
                  <a:txBody>
                    <a:bodyPr/>
                    <a:lstStyle/>
                    <a:p>
                      <a:r>
                        <a:rPr lang="en-US" sz="1000" b="1" dirty="0"/>
                        <a:t>Other Pre-Specified Outcome Measures </a:t>
                      </a:r>
                    </a:p>
                  </a:txBody>
                  <a:tcPr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0" dirty="0"/>
                    </a:p>
                  </a:txBody>
                  <a:tcPr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0" dirty="0"/>
                    </a:p>
                  </a:txBody>
                  <a:tcPr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79152917"/>
                  </a:ext>
                </a:extLst>
              </a:tr>
              <a:tr h="415334">
                <a:tc>
                  <a:txBody>
                    <a:bodyPr/>
                    <a:lstStyle/>
                    <a:p>
                      <a:r>
                        <a:rPr lang="en-US" sz="1000" dirty="0"/>
                        <a:t>Change in physical activity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International physical activity questionnaire short form (IPAQ-sf)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Up to 6 months postoperative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19096665"/>
                  </a:ext>
                </a:extLst>
              </a:tr>
              <a:tr h="415334">
                <a:tc>
                  <a:txBody>
                    <a:bodyPr/>
                    <a:lstStyle/>
                    <a:p>
                      <a:r>
                        <a:rPr lang="en-US" sz="1000" dirty="0"/>
                        <a:t>Change in pain catastrophizing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Pain catastrophizing scale (PCS)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Up to 6 months postoperative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36143854"/>
                  </a:ext>
                </a:extLst>
              </a:tr>
              <a:tr h="415334">
                <a:tc>
                  <a:txBody>
                    <a:bodyPr/>
                    <a:lstStyle/>
                    <a:p>
                      <a:r>
                        <a:rPr lang="en-US" sz="1000" dirty="0"/>
                        <a:t>Change in </a:t>
                      </a:r>
                      <a:r>
                        <a:rPr lang="en-US" sz="1000" dirty="0" err="1"/>
                        <a:t>kinesiophobia</a:t>
                      </a:r>
                      <a:endParaRPr lang="en-US" sz="1000" dirty="0"/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/>
                        <a:t>Tampa scale for kinesiophobia (TSK)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Up to 6 months postoperative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87287729"/>
                  </a:ext>
                </a:extLst>
              </a:tr>
              <a:tr h="415334">
                <a:tc>
                  <a:txBody>
                    <a:bodyPr/>
                    <a:lstStyle/>
                    <a:p>
                      <a:r>
                        <a:rPr lang="en-US" sz="1000" dirty="0"/>
                        <a:t>Change in subjective pain sensitivity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Pain sensitivity questionnaire (PSQ)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Up to 6 months postoperative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80439256"/>
                  </a:ext>
                </a:extLst>
              </a:tr>
              <a:tr h="415334">
                <a:tc>
                  <a:txBody>
                    <a:bodyPr/>
                    <a:lstStyle/>
                    <a:p>
                      <a:r>
                        <a:rPr lang="en-US" sz="1000" dirty="0"/>
                        <a:t>Fibromyalgia severity score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Sum of widespread pain index + symptom severity scale (ACR 2016)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Up to 6 months postoperative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44294831"/>
                  </a:ext>
                </a:extLst>
              </a:tr>
              <a:tr h="415334">
                <a:tc>
                  <a:txBody>
                    <a:bodyPr/>
                    <a:lstStyle/>
                    <a:p>
                      <a:r>
                        <a:rPr lang="en-US" sz="1000" dirty="0"/>
                        <a:t>Pain-related acceptance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Chronic pain acceptance questionnaire (CPAQ-8)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Up to 6 months postoperative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005362"/>
                  </a:ext>
                </a:extLst>
              </a:tr>
              <a:tr h="415334">
                <a:tc>
                  <a:txBody>
                    <a:bodyPr/>
                    <a:lstStyle/>
                    <a:p>
                      <a:r>
                        <a:rPr lang="en-US" sz="1000" dirty="0"/>
                        <a:t>Changes in blood biomarkers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Inflammatory mediators, monoamine metabolites, coagulation system </a:t>
                      </a:r>
                      <a:r>
                        <a:rPr lang="en-US" sz="1000" dirty="0" err="1"/>
                        <a:t>etc</a:t>
                      </a:r>
                      <a:endParaRPr lang="en-US" sz="1000" dirty="0"/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Up to 6 months postoperative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2492616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9720927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36</TotalTime>
  <Words>479</Words>
  <Application>Microsoft Office PowerPoint</Application>
  <PresentationFormat>On-screen Show (4:3)</PresentationFormat>
  <Paragraphs>7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tin Bjurstrom</dc:creator>
  <cp:lastModifiedBy>Martin Bjurstrom</cp:lastModifiedBy>
  <cp:revision>18</cp:revision>
  <dcterms:created xsi:type="dcterms:W3CDTF">2023-11-28T12:20:22Z</dcterms:created>
  <dcterms:modified xsi:type="dcterms:W3CDTF">2025-07-10T13:56:35Z</dcterms:modified>
</cp:coreProperties>
</file>